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15009-8A56-45C8-8403-0092821F4D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1729E-9B04-4DA4-ACFD-6EF8C5A5DB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2AA21-618B-4226-B15B-AA1448E301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F9000-033B-404E-94BC-18DEC83FE6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208C8-4CB5-4978-A0F1-B8CD2CAA91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D4005-BA59-4841-8E47-AE90D2A343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54FB57-5606-4A72-B074-AC528F8F0B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1E182-F9DC-4C10-B3EE-49219A34E0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997E8C-FC6C-44EE-ACF4-94AF26E23D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0317F-FE12-4D16-B07D-B5DF88A56F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3A94D-EAEE-4937-A874-E8000AF477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AB174-B17E-43B3-8B7F-F1E3156D19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4CEC72-2D2D-43E8-8D56-1CF19DBCAF5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5"/>
          <p:cNvSpPr/>
          <p:nvPr/>
        </p:nvSpPr>
        <p:spPr>
          <a:xfrm rot="16200000">
            <a:off x="-480240" y="2381400"/>
            <a:ext cx="318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DIC (Deviance Information Criterion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13"/>
          <p:cNvSpPr/>
          <p:nvPr/>
        </p:nvSpPr>
        <p:spPr>
          <a:xfrm>
            <a:off x="3642480" y="4309920"/>
            <a:ext cx="29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519120" y="4755960"/>
            <a:ext cx="6546960" cy="10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Figure S2 Plot of the DIC value obtained using the InStruct software as a function of the </a:t>
            </a:r>
            <a:r>
              <a:rPr b="0" i="1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 value.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Each point with vertical bar represents the average value </a:t>
            </a:r>
            <a:r>
              <a:rPr b="0" lang="en-US" sz="1400" spc="-1" strike="noStrike" u="sng">
                <a:solidFill>
                  <a:srgbClr val="000000"/>
                </a:solidFill>
                <a:uFillTx/>
                <a:latin typeface="Calibri"/>
                <a:ea typeface="Calibri"/>
              </a:rPr>
              <a:t>+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 standard deviation for all accessions for a given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K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Calibri"/>
              </a:rPr>
              <a:t> value. Five trials were carried out, with a burn-in cycle of 100 000 iterations followed by a further 200 000 iteration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6" descr=""/>
          <p:cNvPicPr/>
          <p:nvPr/>
        </p:nvPicPr>
        <p:blipFill>
          <a:blip r:embed="rId1"/>
          <a:stretch/>
        </p:blipFill>
        <p:spPr>
          <a:xfrm>
            <a:off x="1349280" y="1035000"/>
            <a:ext cx="4579920" cy="330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9T06:17:57Z</dcterms:created>
  <dc:creator>yonemaru</dc:creator>
  <dc:description/>
  <dc:language>en-US</dc:language>
  <cp:lastModifiedBy>yonemaru</cp:lastModifiedBy>
  <dcterms:modified xsi:type="dcterms:W3CDTF">2012-02-12T01:30:54Z</dcterms:modified>
  <cp:revision>16</cp:revision>
  <dc:subject/>
  <dc:title>スライド 1</dc:title>
</cp:coreProperties>
</file>